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0" r:id="rId2"/>
    <p:sldId id="269" r:id="rId3"/>
    <p:sldId id="262" r:id="rId4"/>
  </p:sldIdLst>
  <p:sldSz cx="27432000" cy="2057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24" d="100"/>
          <a:sy n="24" d="100"/>
        </p:scale>
        <p:origin x="13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196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792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7522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411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336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087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624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951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9186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345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009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36062E-A4C9-417D-80E5-1528CD853367}" type="datetimeFigureOut">
              <a:rPr kumimoji="1" lang="ja-JP" altLang="en-US" smtClean="0"/>
              <a:t>2022/11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DC836-FDF5-48EE-AB53-C8B591D01B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6507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EE395C6C-B921-49B7-813E-3BFAAD77AAFD}"/>
              </a:ext>
            </a:extLst>
          </p:cNvPr>
          <p:cNvSpPr/>
          <p:nvPr/>
        </p:nvSpPr>
        <p:spPr>
          <a:xfrm>
            <a:off x="2160704" y="18538182"/>
            <a:ext cx="23110592" cy="9191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Fig. S1 Structures of the compounds used in this study.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29F590B8-FCD0-48D1-A1EB-B03A1C3A2F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80709" y="9338666"/>
            <a:ext cx="11550700" cy="735493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EE31C9B-01C1-4311-B442-B1D3143C92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05222" y="9338666"/>
            <a:ext cx="11046068" cy="735493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1AE3DF2-3C36-40CF-900F-0433CC2731F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80710" y="495569"/>
            <a:ext cx="11005162" cy="7354933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03D143D-6CF9-4A42-98A9-8C547B50CC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5222" y="495569"/>
            <a:ext cx="11046068" cy="7354933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39B74AF-9519-4C00-8D30-4413DA691F1F}"/>
              </a:ext>
            </a:extLst>
          </p:cNvPr>
          <p:cNvSpPr/>
          <p:nvPr/>
        </p:nvSpPr>
        <p:spPr>
          <a:xfrm>
            <a:off x="1307656" y="7722996"/>
            <a:ext cx="1104606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3-</a:t>
            </a:r>
            <a:r>
              <a:rPr lang="en-US" altLang="ja-JP" sz="5400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-caffeoylquinic acid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1DF77D17-7197-4FF4-89B1-75A911E1189E}"/>
              </a:ext>
            </a:extLst>
          </p:cNvPr>
          <p:cNvSpPr/>
          <p:nvPr/>
        </p:nvSpPr>
        <p:spPr>
          <a:xfrm>
            <a:off x="15078277" y="7722996"/>
            <a:ext cx="1100516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5-</a:t>
            </a:r>
            <a:r>
              <a:rPr lang="en-US" altLang="ja-JP" sz="5400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-caffeoylquinic acid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5A6505AD-5D85-4100-B063-CEBCC240D521}"/>
              </a:ext>
            </a:extLst>
          </p:cNvPr>
          <p:cNvSpPr/>
          <p:nvPr/>
        </p:nvSpPr>
        <p:spPr>
          <a:xfrm>
            <a:off x="1307655" y="16695679"/>
            <a:ext cx="11046066" cy="9191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3-</a:t>
            </a:r>
            <a:r>
              <a:rPr lang="en-US" altLang="ja-JP" sz="5400" i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-feruloylquinic acid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F673C001-E426-4190-A0B4-45E08EAD31CB}"/>
              </a:ext>
            </a:extLst>
          </p:cNvPr>
          <p:cNvSpPr/>
          <p:nvPr/>
        </p:nvSpPr>
        <p:spPr>
          <a:xfrm>
            <a:off x="15078278" y="16693600"/>
            <a:ext cx="1155069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5400" dirty="0" err="1">
                <a:latin typeface="Arial" panose="020B0604020202020204" pitchFamily="34" charset="0"/>
                <a:cs typeface="Arial" panose="020B0604020202020204" pitchFamily="34" charset="0"/>
              </a:rPr>
              <a:t>Isoorientin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0443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5DD18262-002D-4523-987A-C3AEFE3893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92971" y="6069318"/>
            <a:ext cx="15026822" cy="11545534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166786D6-21C0-4AB3-8F02-EBC22702E13F}"/>
              </a:ext>
            </a:extLst>
          </p:cNvPr>
          <p:cNvSpPr/>
          <p:nvPr/>
        </p:nvSpPr>
        <p:spPr>
          <a:xfrm>
            <a:off x="1932104" y="17614852"/>
            <a:ext cx="2356779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Fig. S2 Expression of neuronal differentiation marker in </a:t>
            </a:r>
            <a:r>
              <a:rPr lang="en-US" altLang="ja-JP" sz="5400" dirty="0" err="1">
                <a:latin typeface="Arial" panose="020B0604020202020204" pitchFamily="34" charset="0"/>
                <a:cs typeface="Arial" panose="020B0604020202020204" pitchFamily="34" charset="0"/>
              </a:rPr>
              <a:t>hNSCs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 after the addition of samples across the BBB-like structure.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2CB5765B-337F-423B-830E-F0679433F6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5685" y="704185"/>
            <a:ext cx="20061394" cy="5365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4143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237B4FB-B117-4E2B-9258-FC779B483E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775" y="5587056"/>
            <a:ext cx="13182225" cy="5951802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AA3D2D21-3C0D-4EAA-8724-01D3B436FEB4}"/>
              </a:ext>
            </a:extLst>
          </p:cNvPr>
          <p:cNvSpPr/>
          <p:nvPr/>
        </p:nvSpPr>
        <p:spPr>
          <a:xfrm>
            <a:off x="1932104" y="13535882"/>
            <a:ext cx="2356779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Fig. S3 Treatment with 3FQA did not affect the phosphorylation levels of p38 and GSK3</a:t>
            </a:r>
            <a:r>
              <a:rPr lang="el-GR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ja-JP" sz="5400" dirty="0" err="1">
                <a:latin typeface="Arial" panose="020B0604020202020204" pitchFamily="34" charset="0"/>
                <a:cs typeface="Arial" panose="020B0604020202020204" pitchFamily="34" charset="0"/>
              </a:rPr>
              <a:t>hNSC</a:t>
            </a:r>
            <a:r>
              <a:rPr lang="en-US" altLang="ja-JP" sz="5400" dirty="0">
                <a:latin typeface="Arial" panose="020B0604020202020204" pitchFamily="34" charset="0"/>
                <a:cs typeface="Arial" panose="020B0604020202020204" pitchFamily="34" charset="0"/>
              </a:rPr>
              <a:t>-derived immature astrocytes. 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B147EC1-D576-1C1F-A869-810C84ECD1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716000" y="4870835"/>
            <a:ext cx="13444152" cy="8157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0938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2</TotalTime>
  <Words>61</Words>
  <Application>Microsoft Office PowerPoint</Application>
  <PresentationFormat>ユーザー設定</PresentationFormat>
  <Paragraphs>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ニッポー(株) 岩田</dc:creator>
  <cp:lastModifiedBy>Authors</cp:lastModifiedBy>
  <cp:revision>81</cp:revision>
  <dcterms:created xsi:type="dcterms:W3CDTF">2020-06-15T00:54:13Z</dcterms:created>
  <dcterms:modified xsi:type="dcterms:W3CDTF">2022-11-30T08:32:51Z</dcterms:modified>
</cp:coreProperties>
</file>